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19" d="100"/>
          <a:sy n="119" d="100"/>
        </p:scale>
        <p:origin x="760" y="19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mitraserajazari\Desktop\ImageJ%20analysis%20of%20GSH%20imag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val>
            <c:numRef>
              <c:f>Sheet1!$B$134:$V$134</c:f>
              <c:numCache>
                <c:formatCode>General</c:formatCode>
                <c:ptCount val="21"/>
                <c:pt idx="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24-854B-88A9-D4F783CDAC5C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0.25"/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B$135:$V$135</c:f>
              <c:numCache>
                <c:formatCode>0.0</c:formatCode>
                <c:ptCount val="21"/>
                <c:pt idx="1">
                  <c:v>0.722985801906565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924-854B-88A9-D4F783CDAC5C}"/>
            </c:ext>
          </c:extLst>
        </c:ser>
        <c:ser>
          <c:idx val="2"/>
          <c:order val="2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2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36:$V$136</c:f>
              <c:numCache>
                <c:formatCode>General</c:formatCode>
                <c:ptCount val="21"/>
                <c:pt idx="2" formatCode="0.0">
                  <c:v>1.59603315582887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924-854B-88A9-D4F783CDAC5C}"/>
            </c:ext>
          </c:extLst>
        </c:ser>
        <c:ser>
          <c:idx val="3"/>
          <c:order val="3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0.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37:$V$137</c:f>
              <c:numCache>
                <c:formatCode>General</c:formatCode>
                <c:ptCount val="21"/>
                <c:pt idx="3" formatCode="0.0">
                  <c:v>0.593884768330587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924-854B-88A9-D4F783CDAC5C}"/>
            </c:ext>
          </c:extLst>
        </c:ser>
        <c:ser>
          <c:idx val="4"/>
          <c:order val="4"/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Sheet1!$B$138:$V$138</c:f>
              <c:numCache>
                <c:formatCode>General</c:formatCode>
                <c:ptCount val="21"/>
              </c:numCache>
            </c:numRef>
          </c:val>
          <c:extLst>
            <c:ext xmlns:c16="http://schemas.microsoft.com/office/drawing/2014/chart" uri="{C3380CC4-5D6E-409C-BE32-E72D297353CC}">
              <c16:uniqueId val="{00000004-D924-854B-88A9-D4F783CDAC5C}"/>
            </c:ext>
          </c:extLst>
        </c:ser>
        <c:ser>
          <c:idx val="5"/>
          <c:order val="5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0-231B-4BEE-92FD-8D194A6FC3FF}"/>
              </c:ext>
            </c:extLst>
          </c:dPt>
          <c:errBars>
            <c:errBarType val="both"/>
            <c:errValType val="fixedVal"/>
            <c:noEndCap val="0"/>
            <c:val val="1.100000000000000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39:$V$139</c:f>
              <c:numCache>
                <c:formatCode>General</c:formatCode>
                <c:ptCount val="21"/>
                <c:pt idx="5" formatCode="0.0">
                  <c:v>5.859221883718464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924-854B-88A9-D4F783CDAC5C}"/>
            </c:ext>
          </c:extLst>
        </c:ser>
        <c:ser>
          <c:idx val="6"/>
          <c:order val="6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1.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40:$V$140</c:f>
              <c:numCache>
                <c:formatCode>General</c:formatCode>
                <c:ptCount val="21"/>
                <c:pt idx="6" formatCode="0.0">
                  <c:v>9.64143264396186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D924-854B-88A9-D4F783CDAC5C}"/>
            </c:ext>
          </c:extLst>
        </c:ser>
        <c:ser>
          <c:idx val="7"/>
          <c:order val="7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1.2"/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B$141:$V$141</c:f>
              <c:numCache>
                <c:formatCode>General</c:formatCode>
                <c:ptCount val="21"/>
                <c:pt idx="7" formatCode="0.0">
                  <c:v>12.2897050227253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7-D924-854B-88A9-D4F783CDAC5C}"/>
            </c:ext>
          </c:extLst>
        </c:ser>
        <c:ser>
          <c:idx val="8"/>
          <c:order val="8"/>
          <c:spPr>
            <a:solidFill>
              <a:schemeClr val="accent3">
                <a:lumMod val="60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1!$B$142:$V$142</c:f>
              <c:numCache>
                <c:formatCode>General</c:formatCode>
                <c:ptCount val="21"/>
              </c:numCache>
            </c:numRef>
          </c:val>
          <c:extLst>
            <c:ext xmlns:c16="http://schemas.microsoft.com/office/drawing/2014/chart" uri="{C3380CC4-5D6E-409C-BE32-E72D297353CC}">
              <c16:uniqueId val="{00000008-D924-854B-88A9-D4F783CDAC5C}"/>
            </c:ext>
          </c:extLst>
        </c:ser>
        <c:ser>
          <c:idx val="9"/>
          <c:order val="9"/>
          <c:spPr>
            <a:solidFill>
              <a:schemeClr val="bg1">
                <a:lumMod val="65000"/>
              </a:schemeClr>
            </a:solidFill>
            <a:ln>
              <a:noFill/>
            </a:ln>
            <a:effectLst/>
          </c:spPr>
          <c:invertIfNegative val="0"/>
          <c:dPt>
            <c:idx val="9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231B-4BEE-92FD-8D194A6FC3FF}"/>
              </c:ext>
            </c:extLst>
          </c:dPt>
          <c:errBars>
            <c:errBarType val="both"/>
            <c:errValType val="fixedVal"/>
            <c:noEndCap val="0"/>
            <c:val val="1.1000000000000001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43:$V$143</c:f>
              <c:numCache>
                <c:formatCode>General</c:formatCode>
                <c:ptCount val="21"/>
                <c:pt idx="9" formatCode="0.0">
                  <c:v>13.5612997989540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924-854B-88A9-D4F783CDAC5C}"/>
            </c:ext>
          </c:extLst>
        </c:ser>
        <c:ser>
          <c:idx val="10"/>
          <c:order val="10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2.9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44:$V$144</c:f>
              <c:numCache>
                <c:formatCode>General</c:formatCode>
                <c:ptCount val="21"/>
                <c:pt idx="10" formatCode="0.0">
                  <c:v>24.3869235075381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D924-854B-88A9-D4F783CDAC5C}"/>
            </c:ext>
          </c:extLst>
        </c:ser>
        <c:ser>
          <c:idx val="11"/>
          <c:order val="11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1.7"/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B$145:$V$145</c:f>
              <c:numCache>
                <c:formatCode>General</c:formatCode>
                <c:ptCount val="21"/>
                <c:pt idx="11" formatCode="0.0">
                  <c:v>21.0707518019296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D924-854B-88A9-D4F783CDAC5C}"/>
            </c:ext>
          </c:extLst>
        </c:ser>
        <c:ser>
          <c:idx val="12"/>
          <c:order val="12"/>
          <c:spPr>
            <a:solidFill>
              <a:schemeClr val="accent1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1!$B$146:$V$146</c:f>
              <c:numCache>
                <c:formatCode>General</c:formatCode>
                <c:ptCount val="21"/>
              </c:numCache>
            </c:numRef>
          </c:val>
          <c:extLst>
            <c:ext xmlns:c16="http://schemas.microsoft.com/office/drawing/2014/chart" uri="{C3380CC4-5D6E-409C-BE32-E72D297353CC}">
              <c16:uniqueId val="{0000000C-D924-854B-88A9-D4F783CDAC5C}"/>
            </c:ext>
          </c:extLst>
        </c:ser>
        <c:ser>
          <c:idx val="13"/>
          <c:order val="13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47:$V$147</c:f>
              <c:numCache>
                <c:formatCode>General</c:formatCode>
                <c:ptCount val="21"/>
                <c:pt idx="13" formatCode="0.0">
                  <c:v>22.76342498368302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D-D924-854B-88A9-D4F783CDAC5C}"/>
            </c:ext>
          </c:extLst>
        </c:ser>
        <c:ser>
          <c:idx val="14"/>
          <c:order val="14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4.0999999999999996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48:$V$148</c:f>
              <c:numCache>
                <c:formatCode>General</c:formatCode>
                <c:ptCount val="21"/>
                <c:pt idx="14" formatCode="0.0">
                  <c:v>39.3411716768936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D924-854B-88A9-D4F783CDAC5C}"/>
            </c:ext>
          </c:extLst>
        </c:ser>
        <c:ser>
          <c:idx val="15"/>
          <c:order val="15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2.7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49:$V$149</c:f>
              <c:numCache>
                <c:formatCode>General</c:formatCode>
                <c:ptCount val="21"/>
                <c:pt idx="15" formatCode="0.0">
                  <c:v>28.1172720578120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F-D924-854B-88A9-D4F783CDAC5C}"/>
            </c:ext>
          </c:extLst>
        </c:ser>
        <c:ser>
          <c:idx val="16"/>
          <c:order val="16"/>
          <c:spPr>
            <a:solidFill>
              <a:schemeClr val="accent5">
                <a:lumMod val="80000"/>
                <a:lumOff val="20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1!$B$150:$V$150</c:f>
              <c:numCache>
                <c:formatCode>General</c:formatCode>
                <c:ptCount val="21"/>
              </c:numCache>
            </c:numRef>
          </c:val>
          <c:extLst>
            <c:ext xmlns:c16="http://schemas.microsoft.com/office/drawing/2014/chart" uri="{C3380CC4-5D6E-409C-BE32-E72D297353CC}">
              <c16:uniqueId val="{00000010-D924-854B-88A9-D4F783CDAC5C}"/>
            </c:ext>
          </c:extLst>
        </c:ser>
        <c:ser>
          <c:idx val="17"/>
          <c:order val="17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fixedVal"/>
            <c:noEndCap val="0"/>
            <c:val val="2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51:$V$151</c:f>
              <c:numCache>
                <c:formatCode>General</c:formatCode>
                <c:ptCount val="21"/>
                <c:pt idx="17" formatCode="0.0">
                  <c:v>37.8951903224567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1-D924-854B-88A9-D4F783CDAC5C}"/>
            </c:ext>
          </c:extLst>
        </c:ser>
        <c:ser>
          <c:idx val="18"/>
          <c:order val="18"/>
          <c:spPr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5.4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B$152:$V$152</c:f>
              <c:numCache>
                <c:formatCode>General</c:formatCode>
                <c:ptCount val="21"/>
                <c:pt idx="18" formatCode="0.0">
                  <c:v>64.9495288184930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D924-854B-88A9-D4F783CDAC5C}"/>
            </c:ext>
          </c:extLst>
        </c:ser>
        <c:ser>
          <c:idx val="19"/>
          <c:order val="19"/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fixedVal"/>
            <c:noEndCap val="0"/>
            <c:val val="5.3"/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val>
            <c:numRef>
              <c:f>Sheet1!$B$153:$V$153</c:f>
              <c:numCache>
                <c:formatCode>General</c:formatCode>
                <c:ptCount val="21"/>
                <c:pt idx="19" formatCode="0.0">
                  <c:v>49.5652501038001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D924-854B-88A9-D4F783CDAC5C}"/>
            </c:ext>
          </c:extLst>
        </c:ser>
        <c:ser>
          <c:idx val="20"/>
          <c:order val="20"/>
          <c:spPr>
            <a:solidFill>
              <a:schemeClr val="accent3">
                <a:lumMod val="80000"/>
              </a:schemeClr>
            </a:solidFill>
            <a:ln>
              <a:noFill/>
            </a:ln>
            <a:effectLst/>
          </c:spPr>
          <c:invertIfNegative val="0"/>
          <c:val>
            <c:numRef>
              <c:f>Sheet1!$B$154:$V$154</c:f>
              <c:numCache>
                <c:formatCode>General</c:formatCode>
                <c:ptCount val="21"/>
                <c:pt idx="20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4-D924-854B-88A9-D4F783CDAC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0"/>
        <c:overlap val="100"/>
        <c:axId val="324461808"/>
        <c:axId val="324683584"/>
      </c:barChart>
      <c:catAx>
        <c:axId val="324461808"/>
        <c:scaling>
          <c:orientation val="minMax"/>
        </c:scaling>
        <c:delete val="0"/>
        <c:axPos val="b"/>
        <c:numFmt formatCode="@" sourceLinked="0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4683584"/>
        <c:crosses val="autoZero"/>
        <c:auto val="0"/>
        <c:lblAlgn val="ctr"/>
        <c:lblOffset val="100"/>
        <c:tickMarkSkip val="3"/>
        <c:noMultiLvlLbl val="0"/>
      </c:catAx>
      <c:valAx>
        <c:axId val="3246835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24461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CDB135-6066-6C47-B3B2-301071A46BFF}" type="datetimeFigureOut">
              <a:rPr lang="en-US" smtClean="0"/>
              <a:t>5/24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D02301-9C1B-DC45-B1F2-0C8A360607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9595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D02301-9C1B-DC45-B1F2-0C8A360607A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07027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058E0-D6DE-C35D-A3C6-3B7BD6709E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8380E1-ABBD-316A-E9ED-40F75C618C0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0350E8-78F6-059B-0AE9-54181C9096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D4312E-A61B-BC69-1F5E-907DCD7A46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C9730B-183E-BDE9-DB43-14CB0B30D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820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60C5E0-2298-B888-E4E6-565CBC5F39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A32372-51DC-0D42-1642-08F40D1EEC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919484-7872-0A3D-714B-B674671068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C24AE9-E3E9-3D3D-7EBD-9732BD9194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98D624-B8C4-26BF-EF4D-2408680AC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2557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92932E-2E14-8616-836B-C7C7AE67FA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BC81B0-CE98-461C-5CEA-36EF12E672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BCF6FD-645C-6E8F-3177-6894A6EF7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34C71-516C-B279-E549-5116914F1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EB0D55-4979-B749-3271-D8656BFD1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643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1F0468-ED4F-C763-9DBC-8304A31EBD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999B36-670A-336F-3AE6-2553CEBA79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E22EBC-FB6E-107D-4ABA-243132BAD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FE3A8C-9BB8-BEBC-44B4-4A5D4DD116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5B9F6A-75EF-6CB2-DCE3-40002903BA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4938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8989F0-26CC-0344-528D-0EACB239A4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EA8B47-6A5C-6D1E-0121-6BCB48BCCD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B460C5-D3ED-D0DD-CD9E-43DA5BE007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A5D7F-CFF2-B734-04BA-B06886D67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D96977-DC07-2135-6A50-583E9D4FA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916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8074E5-66A6-E607-A8BA-1F4E8BA9F1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FF7781-D1FD-EF32-FDD0-8DC698740E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66CFE17-F32B-094A-40C2-54C208CDDAD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B794FE-1A57-15B8-4530-2D0E569CFB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4049240-8C85-DC85-2208-8A77DD4707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152B75-5B6C-4D11-6CCE-AD2E0BB7B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2903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CD462E-8E2A-7C1D-B943-E0F3E9BA53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F310C5-D7F4-BE0D-4A93-DB2BCE9360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710969-BE5E-1BB4-9FC0-B510C7E2D3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66B66E-F7EB-1DDC-D85E-953AB99909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EDB9DFC-9AA4-EA0F-8BA0-396DA2BFB7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D5326EE-B617-7A59-5148-C58F66F47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8AF54B-4A95-C566-C2C4-C731B2821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9411E1A-E3F9-37BD-26ED-14EBEA62A3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22032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4423B1-868C-5006-233B-116CFB9C74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27CBF17-C0C4-6CD8-F24B-B913701D20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3AEFEE6-93F1-8E43-7A05-0CAA57147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96841EB-1FF2-61D2-2FB9-820B3CB5E6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7554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049BE9-9CD2-99FF-08F3-9B75E591A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BA0638D-BA77-E377-EF5F-000452E9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8C85D12-CEC2-7FD4-185D-82500582F5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245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E5053A-1102-A0DA-3B00-1D0CCDDBC0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D710F3-FEA1-FDC6-0CD2-E72B3CD711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0DBFCA-7DF6-2496-676C-053DC134C5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27780DF-7BBC-33F6-F820-55D539573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E8A4B6-40C6-FE08-A7CA-2342B757B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97FF4FC-BFA1-4AE1-E771-F0D14E0890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4049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7CBCF-7E4C-C527-470B-7E3349A0B0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B5A9A86-C2FD-7379-4CF4-920A199A23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1820BFA-2FA4-873E-5ED5-8D39D3BF2E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2A8E629-7DB9-AEBE-5341-C12D429DD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0C99F5-C41F-FF15-8786-1317074920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BDDBCD3-3062-4083-46F1-989E38CA8B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9897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1B05379-938D-2E0F-1598-E006AFFE48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329561-38B7-3E66-FF07-6BC9A7ED53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5D627C-C9E9-E2EF-BAEF-F94AAEBD21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4FD2C8-8F2A-C947-8F8C-6067C631D995}" type="datetimeFigureOut">
              <a:rPr lang="en-US" smtClean="0"/>
              <a:t>5/24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0A8F47-5887-F138-C7E0-9E3325A53B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0393C9-686F-9532-B8AE-41BE428929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57C6D6-17A7-944A-8524-C545037425A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317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546C41DA-F8A4-822D-4A94-37FD839B874A}"/>
              </a:ext>
            </a:extLst>
          </p:cNvPr>
          <p:cNvGrpSpPr/>
          <p:nvPr/>
        </p:nvGrpSpPr>
        <p:grpSpPr>
          <a:xfrm>
            <a:off x="1692905" y="1115515"/>
            <a:ext cx="8818096" cy="4648701"/>
            <a:chOff x="1466995" y="1233853"/>
            <a:chExt cx="8818096" cy="4648701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3846553F-3335-7096-BFB7-A098AEAFB04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78556850"/>
                </p:ext>
              </p:extLst>
            </p:nvPr>
          </p:nvGraphicFramePr>
          <p:xfrm>
            <a:off x="1888436" y="1233853"/>
            <a:ext cx="8396655" cy="439029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992E82C-8B3F-1286-4A95-5F0D4E81D47C}"/>
                </a:ext>
              </a:extLst>
            </p:cNvPr>
            <p:cNvSpPr txBox="1"/>
            <p:nvPr/>
          </p:nvSpPr>
          <p:spPr>
            <a:xfrm>
              <a:off x="3140607" y="4824842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E31317B6-82D7-A1E2-CEE4-9871AD9567CC}"/>
                </a:ext>
              </a:extLst>
            </p:cNvPr>
            <p:cNvSpPr txBox="1"/>
            <p:nvPr/>
          </p:nvSpPr>
          <p:spPr>
            <a:xfrm rot="16200000">
              <a:off x="698643" y="3251773"/>
              <a:ext cx="19060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eaf cell death (%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59396B2-D79C-77F5-C5E9-AA65ED3B8C9C}"/>
                </a:ext>
              </a:extLst>
            </p:cNvPr>
            <p:cNvSpPr txBox="1"/>
            <p:nvPr/>
          </p:nvSpPr>
          <p:spPr>
            <a:xfrm>
              <a:off x="2877405" y="5544000"/>
              <a:ext cx="82586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No GSH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6F0DEF01-C63D-DC13-8581-3163F9CC150F}"/>
                </a:ext>
              </a:extLst>
            </p:cNvPr>
            <p:cNvSpPr txBox="1"/>
            <p:nvPr/>
          </p:nvSpPr>
          <p:spPr>
            <a:xfrm>
              <a:off x="4189385" y="5544000"/>
              <a:ext cx="117692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50 mM GSH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D1803AD-E12D-DE2E-501E-7942318D1E97}"/>
                </a:ext>
              </a:extLst>
            </p:cNvPr>
            <p:cNvSpPr txBox="1"/>
            <p:nvPr/>
          </p:nvSpPr>
          <p:spPr>
            <a:xfrm>
              <a:off x="5627749" y="5544000"/>
              <a:ext cx="12811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00 mM GSH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A2497F8-23D5-0F75-9F87-420AF6311D25}"/>
                </a:ext>
              </a:extLst>
            </p:cNvPr>
            <p:cNvSpPr txBox="1"/>
            <p:nvPr/>
          </p:nvSpPr>
          <p:spPr>
            <a:xfrm>
              <a:off x="7094394" y="5544000"/>
              <a:ext cx="12811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150 mM GSH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FE850E85-B758-320F-3D02-2F85E358CA92}"/>
                </a:ext>
              </a:extLst>
            </p:cNvPr>
            <p:cNvSpPr txBox="1"/>
            <p:nvPr/>
          </p:nvSpPr>
          <p:spPr>
            <a:xfrm>
              <a:off x="8580630" y="5544000"/>
              <a:ext cx="128112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200 mM GSH</a:t>
              </a: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3C1F766D-2D2A-0E74-C19F-0BFC88A66912}"/>
                </a:ext>
              </a:extLst>
            </p:cNvPr>
            <p:cNvSpPr/>
            <p:nvPr/>
          </p:nvSpPr>
          <p:spPr>
            <a:xfrm>
              <a:off x="2736000" y="1767016"/>
              <a:ext cx="252000" cy="252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55E9E5DE-1AFE-0869-006A-7426F646F57D}"/>
                </a:ext>
              </a:extLst>
            </p:cNvPr>
            <p:cNvSpPr/>
            <p:nvPr/>
          </p:nvSpPr>
          <p:spPr>
            <a:xfrm>
              <a:off x="2736000" y="2141841"/>
              <a:ext cx="252000" cy="2520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09600AC-D636-93F5-1B85-CF2B5ACFEE55}"/>
                </a:ext>
              </a:extLst>
            </p:cNvPr>
            <p:cNvSpPr/>
            <p:nvPr/>
          </p:nvSpPr>
          <p:spPr>
            <a:xfrm>
              <a:off x="2736000" y="2516666"/>
              <a:ext cx="252000" cy="252000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0023F6D7-99A6-0AC2-37BC-1A0921874838}"/>
                </a:ext>
              </a:extLst>
            </p:cNvPr>
            <p:cNvSpPr txBox="1"/>
            <p:nvPr/>
          </p:nvSpPr>
          <p:spPr>
            <a:xfrm>
              <a:off x="3063764" y="1713132"/>
              <a:ext cx="10703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Weed-fre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C98A9496-3CB7-8D5E-58A0-CC96DF0C48AD}"/>
                </a:ext>
              </a:extLst>
            </p:cNvPr>
            <p:cNvSpPr txBox="1"/>
            <p:nvPr/>
          </p:nvSpPr>
          <p:spPr>
            <a:xfrm>
              <a:off x="3053326" y="2103526"/>
              <a:ext cx="1748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Biological low R:FR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5E4CBFA-A20D-2DA3-4C9B-8325CB872732}"/>
                </a:ext>
              </a:extLst>
            </p:cNvPr>
            <p:cNvSpPr txBox="1"/>
            <p:nvPr/>
          </p:nvSpPr>
          <p:spPr>
            <a:xfrm>
              <a:off x="3067940" y="2481394"/>
              <a:ext cx="1692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Artificial low R:FR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8283259-39D8-CD8F-B1C1-EF00B4C71350}"/>
                </a:ext>
              </a:extLst>
            </p:cNvPr>
            <p:cNvSpPr txBox="1"/>
            <p:nvPr/>
          </p:nvSpPr>
          <p:spPr>
            <a:xfrm>
              <a:off x="4630220" y="4364053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A7178953-ECBE-E9E7-3114-3F195A54ACC5}"/>
                </a:ext>
              </a:extLst>
            </p:cNvPr>
            <p:cNvSpPr txBox="1"/>
            <p:nvPr/>
          </p:nvSpPr>
          <p:spPr>
            <a:xfrm>
              <a:off x="4997774" y="4247510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BCF9FA07-70E1-9ED7-13BE-2F1FCCB7AEB2}"/>
                </a:ext>
              </a:extLst>
            </p:cNvPr>
            <p:cNvSpPr txBox="1"/>
            <p:nvPr/>
          </p:nvSpPr>
          <p:spPr>
            <a:xfrm>
              <a:off x="6113312" y="3559022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D9CC8F23-AA27-4772-5EFE-816AB3EB238A}"/>
                </a:ext>
              </a:extLst>
            </p:cNvPr>
            <p:cNvSpPr txBox="1"/>
            <p:nvPr/>
          </p:nvSpPr>
          <p:spPr>
            <a:xfrm>
              <a:off x="6491624" y="3786724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36ACC34-C0B1-120F-EE1E-74FA558A0C32}"/>
                </a:ext>
              </a:extLst>
            </p:cNvPr>
            <p:cNvSpPr txBox="1"/>
            <p:nvPr/>
          </p:nvSpPr>
          <p:spPr>
            <a:xfrm>
              <a:off x="7588904" y="2739468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2BB0FAB-E8A3-4C05-F4BB-9E425B2D9B6B}"/>
                </a:ext>
              </a:extLst>
            </p:cNvPr>
            <p:cNvSpPr txBox="1"/>
            <p:nvPr/>
          </p:nvSpPr>
          <p:spPr>
            <a:xfrm>
              <a:off x="7958072" y="3374348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c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9C433AB1-6A85-E944-56F8-2D2F40DBE9E0}"/>
                </a:ext>
              </a:extLst>
            </p:cNvPr>
            <p:cNvSpPr txBox="1"/>
            <p:nvPr/>
          </p:nvSpPr>
          <p:spPr>
            <a:xfrm>
              <a:off x="9081240" y="1395479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086DD0BF-FBE2-6B4F-6809-302DAC06A347}"/>
                </a:ext>
              </a:extLst>
            </p:cNvPr>
            <p:cNvSpPr txBox="1"/>
            <p:nvPr/>
          </p:nvSpPr>
          <p:spPr>
            <a:xfrm>
              <a:off x="9449798" y="2187959"/>
              <a:ext cx="28767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400" dirty="0"/>
                <a:t>c</a:t>
              </a:r>
            </a:p>
          </p:txBody>
        </p: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5B40A72C-1BF2-FEF1-9701-8AC79E046EE1}"/>
              </a:ext>
            </a:extLst>
          </p:cNvPr>
          <p:cNvSpPr txBox="1"/>
          <p:nvPr/>
        </p:nvSpPr>
        <p:spPr>
          <a:xfrm>
            <a:off x="8928311" y="2800555"/>
            <a:ext cx="287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56D793D-03BB-C991-1365-A27B1807E7AB}"/>
              </a:ext>
            </a:extLst>
          </p:cNvPr>
          <p:cNvSpPr txBox="1"/>
          <p:nvPr/>
        </p:nvSpPr>
        <p:spPr>
          <a:xfrm>
            <a:off x="7444357" y="3571680"/>
            <a:ext cx="287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F89B318-1364-C7C6-AB00-A04299C4419E}"/>
              </a:ext>
            </a:extLst>
          </p:cNvPr>
          <p:cNvSpPr txBox="1"/>
          <p:nvPr/>
        </p:nvSpPr>
        <p:spPr>
          <a:xfrm>
            <a:off x="5960400" y="4064405"/>
            <a:ext cx="287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D4FA064-B74D-76CD-1899-DB229CB0EBFD}"/>
              </a:ext>
            </a:extLst>
          </p:cNvPr>
          <p:cNvSpPr txBox="1"/>
          <p:nvPr/>
        </p:nvSpPr>
        <p:spPr>
          <a:xfrm>
            <a:off x="4477969" y="4463034"/>
            <a:ext cx="287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B049256-F4EE-2300-87CD-DC3B3F417A28}"/>
              </a:ext>
            </a:extLst>
          </p:cNvPr>
          <p:cNvSpPr txBox="1"/>
          <p:nvPr/>
        </p:nvSpPr>
        <p:spPr>
          <a:xfrm>
            <a:off x="3745203" y="4757123"/>
            <a:ext cx="287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D7ED618-05C0-EE2B-36D6-46D2D1D4E9E1}"/>
              </a:ext>
            </a:extLst>
          </p:cNvPr>
          <p:cNvSpPr txBox="1"/>
          <p:nvPr/>
        </p:nvSpPr>
        <p:spPr>
          <a:xfrm>
            <a:off x="2993964" y="4743266"/>
            <a:ext cx="287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40437808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034a106e-6316-442c-ad35-738afd673d2b}" enabled="1" method="Standard" siteId="{cddc1229-ac2a-4b97-b78a-0e5cacb5865c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918</TotalTime>
  <Words>45</Words>
  <Application>Microsoft Macintosh PowerPoint</Application>
  <PresentationFormat>Widescreen</PresentationFormat>
  <Paragraphs>25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san Amirsadeghi</dc:creator>
  <cp:lastModifiedBy>Sasan Amirsadeghi</cp:lastModifiedBy>
  <cp:revision>11</cp:revision>
  <dcterms:created xsi:type="dcterms:W3CDTF">2023-12-29T01:23:30Z</dcterms:created>
  <dcterms:modified xsi:type="dcterms:W3CDTF">2024-05-24T15:24:53Z</dcterms:modified>
</cp:coreProperties>
</file>